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891E84-DC31-4F63-8783-AECC647D7C7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C6E14A-8E43-4C72-888F-9EAC43DDBD6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ED107F-54BF-4B5C-BD79-3FA3FB18BB1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3AEA14-55EA-4E03-96C6-449DB8C0A1E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EB9F6D-3B36-4DDE-8803-145A50EF90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387193-420B-4DEB-85EE-040E402A90A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6CC8C9-E6A2-46EC-BA1D-11B230C3C0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2B65B4-B241-44EE-9F71-3EAC039D11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08479B-E95B-4FAA-87FB-AD6C4568F7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68ACCF-A6D7-48AA-AC7A-5D0DD52EC8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0B8437-9E77-4587-AA38-98D83A3A33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858B99-AD78-4342-AC24-D2473609DA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908F5EF-AC15-4A3C-B6B6-269AE6293CD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-152280" y="0"/>
            <a:ext cx="7238880" cy="4572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Fig. S1 Beclin1, ATG3 and LC3B mRNA -real-time quantitative PC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24"/>
          <p:cNvGrpSpPr/>
          <p:nvPr/>
        </p:nvGrpSpPr>
        <p:grpSpPr>
          <a:xfrm>
            <a:off x="3492360" y="1003320"/>
            <a:ext cx="3021120" cy="7684920"/>
            <a:chOff x="3492360" y="1003320"/>
            <a:chExt cx="3021120" cy="7684920"/>
          </a:xfrm>
        </p:grpSpPr>
        <p:pic>
          <p:nvPicPr>
            <p:cNvPr id="43" name="Object 18" descr=""/>
            <p:cNvPicPr/>
            <p:nvPr/>
          </p:nvPicPr>
          <p:blipFill>
            <a:blip r:embed="rId1"/>
            <a:stretch/>
          </p:blipFill>
          <p:spPr>
            <a:xfrm>
              <a:off x="3492360" y="1003320"/>
              <a:ext cx="3009960" cy="2441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Object 20" descr=""/>
            <p:cNvPicPr/>
            <p:nvPr/>
          </p:nvPicPr>
          <p:blipFill>
            <a:blip r:embed="rId2"/>
            <a:stretch/>
          </p:blipFill>
          <p:spPr>
            <a:xfrm>
              <a:off x="3505320" y="6248520"/>
              <a:ext cx="3008160" cy="2439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Object 21" descr=""/>
            <p:cNvPicPr/>
            <p:nvPr/>
          </p:nvPicPr>
          <p:blipFill>
            <a:blip r:embed="rId3"/>
            <a:stretch/>
          </p:blipFill>
          <p:spPr>
            <a:xfrm>
              <a:off x="3505320" y="3581280"/>
              <a:ext cx="3008160" cy="24400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46" name="Rectangle 22"/>
          <p:cNvSpPr/>
          <p:nvPr/>
        </p:nvSpPr>
        <p:spPr>
          <a:xfrm>
            <a:off x="533520" y="685800"/>
            <a:ext cx="266688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HCT-11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23"/>
          <p:cNvSpPr/>
          <p:nvPr/>
        </p:nvSpPr>
        <p:spPr>
          <a:xfrm>
            <a:off x="3657600" y="698400"/>
            <a:ext cx="266688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HT-2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8" name="Group 29"/>
          <p:cNvGrpSpPr/>
          <p:nvPr/>
        </p:nvGrpSpPr>
        <p:grpSpPr>
          <a:xfrm>
            <a:off x="380880" y="990720"/>
            <a:ext cx="3009960" cy="7543800"/>
            <a:chOff x="380880" y="990720"/>
            <a:chExt cx="3009960" cy="7543800"/>
          </a:xfrm>
        </p:grpSpPr>
        <p:pic>
          <p:nvPicPr>
            <p:cNvPr id="49" name="Object 4" descr=""/>
            <p:cNvPicPr/>
            <p:nvPr/>
          </p:nvPicPr>
          <p:blipFill>
            <a:blip r:embed="rId4"/>
            <a:stretch/>
          </p:blipFill>
          <p:spPr>
            <a:xfrm>
              <a:off x="380880" y="3581280"/>
              <a:ext cx="3009960" cy="2441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Object 7" descr=""/>
            <p:cNvPicPr/>
            <p:nvPr/>
          </p:nvPicPr>
          <p:blipFill>
            <a:blip r:embed="rId5"/>
            <a:stretch/>
          </p:blipFill>
          <p:spPr>
            <a:xfrm>
              <a:off x="380880" y="990720"/>
              <a:ext cx="3009960" cy="2441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Object 26" descr=""/>
            <p:cNvPicPr/>
            <p:nvPr/>
          </p:nvPicPr>
          <p:blipFill>
            <a:blip r:embed="rId6"/>
            <a:stretch/>
          </p:blipFill>
          <p:spPr>
            <a:xfrm>
              <a:off x="380880" y="6095880"/>
              <a:ext cx="3008520" cy="243864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title"/>
          </p:nvPr>
        </p:nvSpPr>
        <p:spPr>
          <a:xfrm>
            <a:off x="228240" y="914040"/>
            <a:ext cx="6172200" cy="7002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nalysis of Beclin1, ATG3 and LC3B mRNA expression by real-time quantitative PCR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PlaceHolder 2"/>
          <p:cNvSpPr>
            <a:spLocks noGrp="1"/>
          </p:cNvSpPr>
          <p:nvPr>
            <p:ph/>
          </p:nvPr>
        </p:nvSpPr>
        <p:spPr>
          <a:xfrm>
            <a:off x="343080" y="1371600"/>
            <a:ext cx="5829120" cy="67960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          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fter appropriate treatments to HCT-116 and HT-29 cells in 6-well plates, RNA was extracted by using TRIzol (Invitrogen,15596-026), and 500ng of RNA was reverse-transcribed to cDNA. The following Primers were used to amplify Beclin1, ATG3 and LC3B products as well as GAPDH as housekeeping control. Primer sequences and their </a:t>
            </a:r>
            <a:r>
              <a:rPr b="0" lang="en-US" sz="1800" spc="-1" strike="noStrike">
                <a:solidFill>
                  <a:srgbClr val="0000ff"/>
                </a:solidFill>
                <a:latin typeface="Times New Roman"/>
              </a:rPr>
              <a:t>respective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PCR fragment lengths for real-time quantitative PCR were as follows: Beclin1 :forward 5’-AGGTTGAGAAAGGCGAGACA-3’ and reverse 5’-ACTGCCTCCTGTGTCTTCAA - 3’. ATG3 :forward 5’-AAGTGGCTGAGTACCTGACC-3’ and reverse 5’-GATCTCCAGCTGCCACAAAC-3’. LC3B :forward 5’-CGCACCTTCGAACAAAGAGT-3’ and reverse 5’-AGCTGCTTCTCACCCTTGTA-3’. GAPDH :forward 5’-CAAATTCCATGGCACCGTCA-3’ and reverse 5’-ATCTCGCTCCTGGAAGATGG-3’. Beclin1, ATG3 and LC3B mRNA level was determined by using PrimeScript RT reagent Kit (Perfect Real Time) (TAKARA, RR037A)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矩形 5"/>
          <p:cNvSpPr/>
          <p:nvPr/>
        </p:nvSpPr>
        <p:spPr>
          <a:xfrm>
            <a:off x="232920" y="228600"/>
            <a:ext cx="913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Fig. S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/>
          </p:nvPr>
        </p:nvSpPr>
        <p:spPr>
          <a:xfrm>
            <a:off x="343080" y="2133360"/>
            <a:ext cx="3009600" cy="6033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6" name=""/>
          <p:cNvGraphicFramePr/>
          <p:nvPr/>
        </p:nvGraphicFramePr>
        <p:xfrm>
          <a:off x="304920" y="762120"/>
          <a:ext cx="6400800" cy="4876560"/>
        </p:xfrm>
        <a:graphic>
          <a:graphicData uri="http://schemas.openxmlformats.org/drawingml/2006/table">
            <a:tbl>
              <a:tblPr/>
              <a:tblGrid>
                <a:gridCol w="914400"/>
                <a:gridCol w="1295280"/>
                <a:gridCol w="762120"/>
                <a:gridCol w="3429000"/>
              </a:tblGrid>
              <a:tr h="6091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rotein Name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ene Name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ene ID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rimer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670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eclin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ECN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678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orward 5’-AGGTTGAGAAAGGCGAGACA-3’ and reverse 5’-ACTGCCTCCTGTGTCTTCAA - 3’.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6668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TG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TG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442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orward 5’-AAGTGGCTGAGTACCTGACC-3’ and reverse 5’-GATCTCCAGCTGCCACAAAC-3’.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6668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C3B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AP1LC3B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163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orward 5’-CGCACCTTCGAACAAAGAGT-3’ and reverse 5’-AGCTGCTTCTCACCCTTGTA-3’.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670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APDH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APDH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597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orward 5’-CAAATTCCATGGCACCGTCA-3’ and reverse 5’-ATCTCGCTCCTGGAAGATGG-3’.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7" name="矩形 36"/>
          <p:cNvSpPr/>
          <p:nvPr/>
        </p:nvSpPr>
        <p:spPr>
          <a:xfrm>
            <a:off x="232920" y="152280"/>
            <a:ext cx="913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Fig. S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1-06T02:24:02Z</dcterms:created>
  <dc:creator/>
  <dc:description/>
  <dc:language>en-US</dc:language>
  <cp:lastModifiedBy>Administrator</cp:lastModifiedBy>
  <dcterms:modified xsi:type="dcterms:W3CDTF">2016-01-06T02:37:55Z</dcterms:modified>
  <cp:revision>35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5400</vt:lpwstr>
  </property>
  <property fmtid="{D5CDD505-2E9C-101B-9397-08002B2CF9AE}" pid="3" name="Version">
    <vt:r8>1</vt:r8>
  </property>
</Properties>
</file>